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0" r:id="rId2"/>
    <p:sldId id="29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242FF"/>
    <a:srgbClr val="72ECA6"/>
    <a:srgbClr val="FFC69D"/>
    <a:srgbClr val="FFFFFF"/>
    <a:srgbClr val="F8F8F8"/>
    <a:srgbClr val="1C86EE"/>
    <a:srgbClr val="17C0FF"/>
    <a:srgbClr val="80FF0A"/>
    <a:srgbClr val="B2B201"/>
    <a:srgbClr val="FFA61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2" autoAdjust="0"/>
    <p:restoredTop sz="94980" autoAdjust="0"/>
  </p:normalViewPr>
  <p:slideViewPr>
    <p:cSldViewPr snapToGrid="0">
      <p:cViewPr varScale="1">
        <p:scale>
          <a:sx n="114" d="100"/>
          <a:sy n="114" d="100"/>
        </p:scale>
        <p:origin x="47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9E265F-ADF2-4B27-B7AB-E2D6CEC44303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2A3435-B77F-4172-B04E-CA4EAA3DF0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145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6A540A-E49C-F9A3-9AFF-E4F7CD7EB9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DA01DE-9AA4-E286-DE38-30D7E63EEB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0F589D-F650-AE8A-C824-ABF00EEFA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CF7655-98D3-02DB-8E10-D91F106CE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B800E1-A430-45B2-0FCD-DFBD226DF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984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A1EA4-899E-D102-EADC-028FBFF3FE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4E06DD-D257-9487-DFE2-75A9571A42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AEF064-17E8-5FC6-5AB8-34F05B041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244BC3-0234-EF24-5281-EB816A1547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20FD4C-000D-FF7D-E8EB-A2EDC8F60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450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DC4CFC-EED2-9C76-48DD-156A456DCA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59EDEC-EAC7-8673-FC2A-BB30EA4979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3B1DD0-D5B8-3BBA-C75D-39B700156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B8F620-C5D3-0AB7-ECFB-5E65FEA44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978382-646E-8216-CA35-6F1DE2B97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80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B245D-FBD0-DE2E-D67F-2C45862DAC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D83C2F-CAA0-DF5B-0DD9-E590080FE8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BABA73-A6BB-A56A-C75A-A51769760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2215B8-F994-3937-FE7F-EFEFD0D53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748BC3-DC6B-975D-728D-B5EF2438F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093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01D4D-1422-1EF6-A181-3AC8B7E2C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AF568B-8320-2C69-0CA6-AA8599D4B4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893C0C-216D-6E46-8973-42E1665BE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E09EF0-32D0-7F85-3FF5-D82037D52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E4342-995C-0BE1-723B-E913602CF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645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EE0B7D-D78D-5EB9-866D-BA4A9C1A63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8A1B54-5A77-6C52-5D4B-6F87F0B6D3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6B33FA-068D-D3BB-D546-D07DF11232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CF37DD-18EC-CA4C-84D1-8F8EB9D16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09DBE5-6C0A-E4D4-393F-E5304F9D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B2D7DD-AF92-C4F8-CE8C-6EF1B5B12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204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59486D-9C46-8588-A2DE-7595F2056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72BD61-DAF8-3489-7A40-084895CEC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36BA58-FCF4-DC00-06EE-877C4AA333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ADC3AA-027E-5423-39D9-E98F1EDF1C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357DA5-A857-4AFA-170F-C316D9C535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E9C6A8-5C96-DFEC-9A5B-1AA1CC23E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011464-886E-FD6B-18F4-F33AAA647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901D64-AF68-636F-43AE-A7BC927F7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792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115CE-0976-8086-E0FB-D420D207B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C3E6EC-3E9A-26BB-5B1E-972A89A76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DF7354-9B09-47D6-56B3-6AF07A511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0AF082-1567-19F5-73A4-A01B335C1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164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D3AED9-5B71-9EE3-386F-F98724D27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921158-6227-B028-7C22-877222EE6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B22230-3DDE-54E3-8535-8925879F8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69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14342-E7B8-D32F-DD9D-C0B048703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77AEBE-EB3D-F570-9B24-CCE158FA2A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61A51D-47AE-96FD-C137-90711D43B3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B08891-BD2F-7991-57CE-CA5C93843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84A763-864E-CBCD-1BF9-B7A2C0E67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477901-F012-FFC6-C303-454B6C51C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167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8D224-00CF-4ADA-C87B-B1755C1EA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200887-937C-A597-4053-3DA94EF685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0B1E6C-31D7-24CA-29B3-52F4B8E739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88DFA1-DFD9-1BB3-06B9-BDE0F11DD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C94891-96BE-4BBB-1867-492BACA6D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212839-0533-3E7A-DD3D-6884B5941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2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BA8EB3-43CE-643E-8B47-EB7BEF87E3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600F83-4E09-60C4-0C26-17040F3ADA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461206-A906-6C00-F4FD-D7ABF75655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FB0A50-81E6-4490-B99D-F52B115B71F6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D18E4A-0274-434C-7DC8-8719CAA6A8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718D3-D051-D5A7-4EB3-7A70DE655C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A5DB58-6089-4E2B-8F50-E3693C8E6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28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78011A0-9809-E7A4-04AE-7FF45B969022}"/>
              </a:ext>
            </a:extLst>
          </p:cNvPr>
          <p:cNvSpPr txBox="1"/>
          <p:nvPr/>
        </p:nvSpPr>
        <p:spPr>
          <a:xfrm>
            <a:off x="296944" y="42892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altLang="zh-CN" dirty="0"/>
              <a:t>S</a:t>
            </a:r>
            <a:r>
              <a:rPr lang="en-US" dirty="0"/>
              <a:t>1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D08247A-7807-51C2-8E95-98DF0AF991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0837" y="1566583"/>
            <a:ext cx="5188146" cy="210330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7C64D17-6A58-230D-2396-7B9286ED9018}"/>
              </a:ext>
            </a:extLst>
          </p:cNvPr>
          <p:cNvSpPr txBox="1"/>
          <p:nvPr/>
        </p:nvSpPr>
        <p:spPr>
          <a:xfrm>
            <a:off x="2780837" y="981808"/>
            <a:ext cx="9941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Negative contro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0C5D885-93CF-17D3-3174-1F3E5EC2A5BE}"/>
              </a:ext>
            </a:extLst>
          </p:cNvPr>
          <p:cNvSpPr txBox="1"/>
          <p:nvPr/>
        </p:nvSpPr>
        <p:spPr>
          <a:xfrm>
            <a:off x="3893607" y="1274195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DMS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0EB71E-6F32-1A7A-D16C-58B47C7F9CBB}"/>
              </a:ext>
            </a:extLst>
          </p:cNvPr>
          <p:cNvSpPr txBox="1"/>
          <p:nvPr/>
        </p:nvSpPr>
        <p:spPr>
          <a:xfrm>
            <a:off x="5007539" y="1274195"/>
            <a:ext cx="574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HH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59E6DFA-39FA-927E-7BFA-DE4E0B798105}"/>
              </a:ext>
            </a:extLst>
          </p:cNvPr>
          <p:cNvSpPr txBox="1"/>
          <p:nvPr/>
        </p:nvSpPr>
        <p:spPr>
          <a:xfrm>
            <a:off x="6031917" y="1274195"/>
            <a:ext cx="5870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HX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2175CAF-3A52-6774-77E8-8E2940A4CF11}"/>
              </a:ext>
            </a:extLst>
          </p:cNvPr>
          <p:cNvSpPr txBox="1"/>
          <p:nvPr/>
        </p:nvSpPr>
        <p:spPr>
          <a:xfrm>
            <a:off x="6962030" y="1274195"/>
            <a:ext cx="825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MP1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21DDEA1-8803-5874-B2B4-AD1E908E9E4B}"/>
              </a:ext>
            </a:extLst>
          </p:cNvPr>
          <p:cNvSpPr txBox="1"/>
          <p:nvPr/>
        </p:nvSpPr>
        <p:spPr>
          <a:xfrm>
            <a:off x="7851149" y="2931221"/>
            <a:ext cx="128054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4242FF"/>
                </a:solidFill>
              </a:rPr>
              <a:t>DAPI</a:t>
            </a:r>
          </a:p>
          <a:p>
            <a:r>
              <a:rPr lang="en-US" sz="1400" dirty="0"/>
              <a:t>Puro-</a:t>
            </a:r>
            <a:r>
              <a:rPr lang="en-US" sz="1400" dirty="0" err="1"/>
              <a:t>Myc</a:t>
            </a:r>
            <a:r>
              <a:rPr lang="en-US" sz="1400" dirty="0"/>
              <a:t>-PLA</a:t>
            </a:r>
          </a:p>
          <a:p>
            <a:r>
              <a:rPr lang="en-US" sz="1400" dirty="0">
                <a:solidFill>
                  <a:srgbClr val="FF0000"/>
                </a:solidFill>
              </a:rPr>
              <a:t>Tubulin </a:t>
            </a:r>
            <a:r>
              <a:rPr lang="en-US" sz="1400" dirty="0">
                <a:solidFill>
                  <a:srgbClr val="FF0000"/>
                </a:solidFill>
                <a:latin typeface="Symbol" panose="05050102010706020507" pitchFamily="18" charset="2"/>
              </a:rPr>
              <a:t>b</a:t>
            </a:r>
            <a:r>
              <a:rPr lang="en-US" sz="1400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330907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96FD1B-3CEA-B418-548E-43C67231EF8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07D4F98-7B96-BF59-9BE1-B29F7472F820}"/>
              </a:ext>
            </a:extLst>
          </p:cNvPr>
          <p:cNvSpPr txBox="1"/>
          <p:nvPr/>
        </p:nvSpPr>
        <p:spPr>
          <a:xfrm>
            <a:off x="3075833" y="1553986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9012B66-228E-4CE3-4332-0860DD9DDEFE}"/>
              </a:ext>
            </a:extLst>
          </p:cNvPr>
          <p:cNvSpPr txBox="1"/>
          <p:nvPr/>
        </p:nvSpPr>
        <p:spPr>
          <a:xfrm>
            <a:off x="3948652" y="1553986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7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F9ACAE0-0A51-7700-30C7-706F7DA1E59C}"/>
              </a:ext>
            </a:extLst>
          </p:cNvPr>
          <p:cNvSpPr txBox="1"/>
          <p:nvPr/>
        </p:nvSpPr>
        <p:spPr>
          <a:xfrm>
            <a:off x="4887194" y="1553986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1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ACCB654-AB98-0C97-AB5F-43B3B37F132B}"/>
              </a:ext>
            </a:extLst>
          </p:cNvPr>
          <p:cNvSpPr txBox="1"/>
          <p:nvPr/>
        </p:nvSpPr>
        <p:spPr>
          <a:xfrm>
            <a:off x="5831668" y="1553986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9720B8B-880C-4912-2D07-7EFE71F955A7}"/>
              </a:ext>
            </a:extLst>
          </p:cNvPr>
          <p:cNvSpPr txBox="1"/>
          <p:nvPr/>
        </p:nvSpPr>
        <p:spPr>
          <a:xfrm>
            <a:off x="6704487" y="1553986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7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3C1AC3-34FB-5722-6183-ED59FB01B25C}"/>
              </a:ext>
            </a:extLst>
          </p:cNvPr>
          <p:cNvSpPr txBox="1"/>
          <p:nvPr/>
        </p:nvSpPr>
        <p:spPr>
          <a:xfrm>
            <a:off x="7643029" y="1553986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1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02A976-16FD-F9F1-D512-ABAE4AA695E6}"/>
              </a:ext>
            </a:extLst>
          </p:cNvPr>
          <p:cNvSpPr txBox="1"/>
          <p:nvPr/>
        </p:nvSpPr>
        <p:spPr>
          <a:xfrm>
            <a:off x="2989890" y="1235898"/>
            <a:ext cx="26767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1 hou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4267E75-E082-FD5C-6ABC-611CDF3EBB32}"/>
              </a:ext>
            </a:extLst>
          </p:cNvPr>
          <p:cNvSpPr txBox="1"/>
          <p:nvPr/>
        </p:nvSpPr>
        <p:spPr>
          <a:xfrm>
            <a:off x="5765943" y="1232575"/>
            <a:ext cx="26767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4 hour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BE64980-2AD4-0013-0B7E-1F3F1E30172D}"/>
              </a:ext>
            </a:extLst>
          </p:cNvPr>
          <p:cNvSpPr txBox="1"/>
          <p:nvPr/>
        </p:nvSpPr>
        <p:spPr>
          <a:xfrm>
            <a:off x="8398379" y="3542074"/>
            <a:ext cx="5069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1C86EE"/>
                </a:solidFill>
              </a:rPr>
              <a:t>DAPI</a:t>
            </a:r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C36C86C6-E01C-01DD-F323-E33C12A7081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0750" t="6083" r="64132" b="80688"/>
          <a:stretch>
            <a:fillRect/>
          </a:stretch>
        </p:blipFill>
        <p:spPr>
          <a:xfrm>
            <a:off x="2989890" y="1842834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5A8B63E7-7DE5-0958-9151-C148EA49C96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8244" t="52940" r="9158" b="36036"/>
          <a:stretch>
            <a:fillRect/>
          </a:stretch>
        </p:blipFill>
        <p:spPr>
          <a:xfrm>
            <a:off x="4802595" y="1842834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8D343298-B0B9-5C3A-1A1D-47F4E09011B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7778" t="48377" r="29624" b="40599"/>
          <a:stretch>
            <a:fillRect/>
          </a:stretch>
        </p:blipFill>
        <p:spPr>
          <a:xfrm>
            <a:off x="3896242" y="1842834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69649B4C-8CBF-7E38-9DC4-B4E6BD2958E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0370" t="12361" r="37031" b="76615"/>
          <a:stretch>
            <a:fillRect/>
          </a:stretch>
        </p:blipFill>
        <p:spPr>
          <a:xfrm>
            <a:off x="5765943" y="1842834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CFA48611-ECBE-2DAE-6161-90364D0F7FD2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5741" t="45231" r="71661" b="43745"/>
          <a:stretch>
            <a:fillRect/>
          </a:stretch>
        </p:blipFill>
        <p:spPr>
          <a:xfrm>
            <a:off x="7578648" y="1842834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EBE7B971-2C8D-EB1E-4D2E-FD08B89B3E8A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6778" t="43611" r="78104" b="43161"/>
          <a:stretch>
            <a:fillRect/>
          </a:stretch>
        </p:blipFill>
        <p:spPr>
          <a:xfrm>
            <a:off x="6672295" y="1842834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B7AD92EB-1450-2AA3-F3F8-1337773A24ED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2615" t="32976" r="74787" b="56001"/>
          <a:stretch>
            <a:fillRect/>
          </a:stretch>
        </p:blipFill>
        <p:spPr>
          <a:xfrm>
            <a:off x="2989890" y="3331836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512BC670-B24F-A978-3553-57F78C0A62A2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31079" t="53445" r="56322" b="35532"/>
          <a:stretch>
            <a:fillRect/>
          </a:stretch>
        </p:blipFill>
        <p:spPr>
          <a:xfrm>
            <a:off x="4802595" y="3331836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4F5E5F72-C013-3E06-9681-12369CEBAA43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65729" t="62621" r="21673" b="26355"/>
          <a:stretch>
            <a:fillRect/>
          </a:stretch>
        </p:blipFill>
        <p:spPr>
          <a:xfrm>
            <a:off x="3896242" y="3331836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107" name="Picture 106">
            <a:extLst>
              <a:ext uri="{FF2B5EF4-FFF2-40B4-BE49-F238E27FC236}">
                <a16:creationId xmlns:a16="http://schemas.microsoft.com/office/drawing/2014/main" id="{236CDFE0-E536-5170-4939-9E771D408ECD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69431" t="23324" r="17970" b="65652"/>
          <a:stretch>
            <a:fillRect/>
          </a:stretch>
        </p:blipFill>
        <p:spPr>
          <a:xfrm>
            <a:off x="5765943" y="3358586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3A97FE8F-4660-AB6A-D1D6-E2C6B126E55C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58092" t="53355" r="29310" b="35621"/>
          <a:stretch>
            <a:fillRect/>
          </a:stretch>
        </p:blipFill>
        <p:spPr>
          <a:xfrm>
            <a:off x="7578648" y="3358586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pic>
        <p:nvPicPr>
          <p:cNvPr id="114" name="Picture 113">
            <a:extLst>
              <a:ext uri="{FF2B5EF4-FFF2-40B4-BE49-F238E27FC236}">
                <a16:creationId xmlns:a16="http://schemas.microsoft.com/office/drawing/2014/main" id="{DF59B5E0-E261-48AC-C887-CC8D0BDA0BA7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20065" t="56948" r="67337" b="32028"/>
          <a:stretch>
            <a:fillRect/>
          </a:stretch>
        </p:blipFill>
        <p:spPr>
          <a:xfrm>
            <a:off x="6672295" y="3358586"/>
            <a:ext cx="864000" cy="756000"/>
          </a:xfrm>
          <a:custGeom>
            <a:avLst/>
            <a:gdLst>
              <a:gd name="connsiteX0" fmla="*/ 0 w 864000"/>
              <a:gd name="connsiteY0" fmla="*/ 0 h 756000"/>
              <a:gd name="connsiteX1" fmla="*/ 864000 w 864000"/>
              <a:gd name="connsiteY1" fmla="*/ 0 h 756000"/>
              <a:gd name="connsiteX2" fmla="*/ 864000 w 864000"/>
              <a:gd name="connsiteY2" fmla="*/ 756000 h 756000"/>
              <a:gd name="connsiteX3" fmla="*/ 0 w 864000"/>
              <a:gd name="connsiteY3" fmla="*/ 756000 h 756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64000" h="756000">
                <a:moveTo>
                  <a:pt x="0" y="0"/>
                </a:moveTo>
                <a:lnTo>
                  <a:pt x="864000" y="0"/>
                </a:lnTo>
                <a:lnTo>
                  <a:pt x="864000" y="756000"/>
                </a:lnTo>
                <a:lnTo>
                  <a:pt x="0" y="756000"/>
                </a:lnTo>
                <a:close/>
              </a:path>
            </a:pathLst>
          </a:custGeom>
        </p:spPr>
      </p:pic>
      <p:sp>
        <p:nvSpPr>
          <p:cNvPr id="140" name="TextBox 139">
            <a:extLst>
              <a:ext uri="{FF2B5EF4-FFF2-40B4-BE49-F238E27FC236}">
                <a16:creationId xmlns:a16="http://schemas.microsoft.com/office/drawing/2014/main" id="{99FB5559-DB6A-E611-E08D-7631AFAB8E56}"/>
              </a:ext>
            </a:extLst>
          </p:cNvPr>
          <p:cNvSpPr txBox="1"/>
          <p:nvPr/>
        </p:nvSpPr>
        <p:spPr>
          <a:xfrm>
            <a:off x="3075833" y="3064540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777B56E5-131F-E380-D83C-1E9016952D73}"/>
              </a:ext>
            </a:extLst>
          </p:cNvPr>
          <p:cNvSpPr txBox="1"/>
          <p:nvPr/>
        </p:nvSpPr>
        <p:spPr>
          <a:xfrm>
            <a:off x="3948652" y="3064540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76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90147F7B-2721-BC43-5755-96DB2638C4FF}"/>
              </a:ext>
            </a:extLst>
          </p:cNvPr>
          <p:cNvSpPr txBox="1"/>
          <p:nvPr/>
        </p:nvSpPr>
        <p:spPr>
          <a:xfrm>
            <a:off x="4887194" y="3064540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16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C86EE86F-13F0-057D-3E30-D73BBA1896BD}"/>
              </a:ext>
            </a:extLst>
          </p:cNvPr>
          <p:cNvSpPr txBox="1"/>
          <p:nvPr/>
        </p:nvSpPr>
        <p:spPr>
          <a:xfrm>
            <a:off x="5831668" y="3064540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0D0422BF-7C2A-9491-F757-A4DEB93B25C6}"/>
              </a:ext>
            </a:extLst>
          </p:cNvPr>
          <p:cNvSpPr txBox="1"/>
          <p:nvPr/>
        </p:nvSpPr>
        <p:spPr>
          <a:xfrm>
            <a:off x="6704487" y="3064540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76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6DBD4370-2552-974D-196F-FF7DAF3EECDC}"/>
              </a:ext>
            </a:extLst>
          </p:cNvPr>
          <p:cNvSpPr txBox="1"/>
          <p:nvPr/>
        </p:nvSpPr>
        <p:spPr>
          <a:xfrm>
            <a:off x="7643029" y="3064540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MP16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14701C2-CA81-85AD-5272-92DB18EA1127}"/>
              </a:ext>
            </a:extLst>
          </p:cNvPr>
          <p:cNvSpPr txBox="1"/>
          <p:nvPr/>
        </p:nvSpPr>
        <p:spPr>
          <a:xfrm>
            <a:off x="2989890" y="2746452"/>
            <a:ext cx="26767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8 hour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7E18490B-3709-990F-E703-F4F302D0ED50}"/>
              </a:ext>
            </a:extLst>
          </p:cNvPr>
          <p:cNvSpPr txBox="1"/>
          <p:nvPr/>
        </p:nvSpPr>
        <p:spPr>
          <a:xfrm>
            <a:off x="5765943" y="2743129"/>
            <a:ext cx="267670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24 hours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755743E0-D2FF-430B-B79C-D85EF6C32AB1}"/>
              </a:ext>
            </a:extLst>
          </p:cNvPr>
          <p:cNvSpPr txBox="1"/>
          <p:nvPr/>
        </p:nvSpPr>
        <p:spPr>
          <a:xfrm>
            <a:off x="8398379" y="3899389"/>
            <a:ext cx="6943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G3BP1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D9655EBB-F020-2B90-EAC8-B5D74BE6F359}"/>
              </a:ext>
            </a:extLst>
          </p:cNvPr>
          <p:cNvSpPr txBox="1"/>
          <p:nvPr/>
        </p:nvSpPr>
        <p:spPr>
          <a:xfrm>
            <a:off x="8398379" y="3720732"/>
            <a:ext cx="4636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yc</a:t>
            </a:r>
            <a:endParaRPr lang="en-IL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281AD3-ED82-1627-CB3A-DA778B1C5862}"/>
              </a:ext>
            </a:extLst>
          </p:cNvPr>
          <p:cNvSpPr txBox="1"/>
          <p:nvPr/>
        </p:nvSpPr>
        <p:spPr>
          <a:xfrm>
            <a:off x="9481192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Figure S2</a:t>
            </a:r>
            <a:endParaRPr lang="en-US" dirty="0"/>
          </a:p>
        </p:txBody>
      </p:sp>
      <p:sp>
        <p:nvSpPr>
          <p:cNvPr id="4" name="Arrow: Down 3">
            <a:extLst>
              <a:ext uri="{FF2B5EF4-FFF2-40B4-BE49-F238E27FC236}">
                <a16:creationId xmlns:a16="http://schemas.microsoft.com/office/drawing/2014/main" id="{C65E3B5B-7BEB-8787-5858-A82C1A1DE409}"/>
              </a:ext>
            </a:extLst>
          </p:cNvPr>
          <p:cNvSpPr/>
          <p:nvPr/>
        </p:nvSpPr>
        <p:spPr>
          <a:xfrm>
            <a:off x="4349339" y="3429000"/>
            <a:ext cx="91440" cy="91440"/>
          </a:xfrm>
          <a:prstGeom prst="downArrow">
            <a:avLst/>
          </a:prstGeom>
          <a:solidFill>
            <a:schemeClr val="bg1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Down 13">
            <a:extLst>
              <a:ext uri="{FF2B5EF4-FFF2-40B4-BE49-F238E27FC236}">
                <a16:creationId xmlns:a16="http://schemas.microsoft.com/office/drawing/2014/main" id="{A258619D-5928-B6EA-E894-1E3E629851C7}"/>
              </a:ext>
            </a:extLst>
          </p:cNvPr>
          <p:cNvSpPr/>
          <p:nvPr/>
        </p:nvSpPr>
        <p:spPr>
          <a:xfrm>
            <a:off x="7104295" y="3542074"/>
            <a:ext cx="91440" cy="91440"/>
          </a:xfrm>
          <a:prstGeom prst="downArrow">
            <a:avLst/>
          </a:prstGeom>
          <a:solidFill>
            <a:schemeClr val="bg1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AE161CC7-8368-011A-BA8E-6B87921F4483}"/>
              </a:ext>
            </a:extLst>
          </p:cNvPr>
          <p:cNvSpPr/>
          <p:nvPr/>
        </p:nvSpPr>
        <p:spPr>
          <a:xfrm>
            <a:off x="7820187" y="2050300"/>
            <a:ext cx="91440" cy="91440"/>
          </a:xfrm>
          <a:prstGeom prst="downArrow">
            <a:avLst/>
          </a:prstGeom>
          <a:solidFill>
            <a:schemeClr val="bg1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960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403</TotalTime>
  <Words>39</Words>
  <Application>Microsoft Office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s Alroy</dc:creator>
  <cp:lastModifiedBy>MDPI</cp:lastModifiedBy>
  <cp:revision>68</cp:revision>
  <dcterms:created xsi:type="dcterms:W3CDTF">2025-04-29T06:01:32Z</dcterms:created>
  <dcterms:modified xsi:type="dcterms:W3CDTF">2025-08-22T10:12:08Z</dcterms:modified>
</cp:coreProperties>
</file>